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2A5CF5-5087-4488-A7BA-C3593394D0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34131E-4E25-4F9F-B44E-06A937ABF9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467B2F-805B-490A-98CD-A4A491D5B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63633-EAAC-4D73-8CD4-1F8AA98BFCAF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BDD919-B6ED-4527-8AE8-0E86F9F8F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CF5719-86DF-4252-AA37-61CE11F5C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E7812-F021-47EE-B160-0680F63B6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236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CA58EA-6DAC-443C-B052-C4B4913CB4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009211-BDFE-4286-9126-CA5F3DDF01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3CDAED-4A45-443D-9EA7-D816782451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63633-EAAC-4D73-8CD4-1F8AA98BFCAF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EADA2E-32F0-4DE2-9004-F9FC8265F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3F13A3-4F8B-48F4-A128-B2837DC3D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E7812-F021-47EE-B160-0680F63B6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0955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AA3AB0-5FF2-4E49-891C-C0339E5E42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4CBD86-40F5-47BF-A5AF-19A5149272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C09457-F98C-45DF-BB99-DA4FD63A33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63633-EAAC-4D73-8CD4-1F8AA98BFCAF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0CB67C-61E7-4BE4-8EEF-92C4B6592B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BF4AD6-9F8A-437D-BB0E-AABF56730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E7812-F021-47EE-B160-0680F63B6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8303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9E3829-CC7F-4879-931F-F255BC91C8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83D0CF-26BD-4755-A2F2-2DF4D5F55C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423B5B-0E9F-4DE8-AF6A-8F068EC6CF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63633-EAAC-4D73-8CD4-1F8AA98BFCAF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0700AB-8ADC-4FBA-8FBE-6685A43777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77D909-2223-4F21-B7C9-E5D481781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E7812-F021-47EE-B160-0680F63B6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6797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9238F6-9F34-4039-983A-CE048E5F0D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826269-B095-4AC3-B451-1944F93ED5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7DC282-A2B1-4147-A1C4-58C5B457F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63633-EAAC-4D73-8CD4-1F8AA98BFCAF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6D0F53-21C4-4F2D-887C-7E23450EF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02692C-D3C1-4C5F-97F3-0362F26A6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E7812-F021-47EE-B160-0680F63B6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5315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234518-749F-4935-858B-6B0A006956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D43C30-AB82-47F0-ADD0-870E4E4A03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73FFB1-4AC9-4306-A50D-683F34A258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488D5C-7DAA-4067-B76B-B66D9E96A7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63633-EAAC-4D73-8CD4-1F8AA98BFCAF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31BE2F-5532-4CA3-9A7E-02DBB5386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CB1D12-ECE8-47B1-9324-F3B4CFCC6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E7812-F021-47EE-B160-0680F63B6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8222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852F66-C3CD-42AC-8285-9B2B99E3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C8FF78-085C-4BAC-910D-3930F4C0E9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8114E5-ACB6-4FDD-9AFC-259E0125A9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127E24F-CE8C-48C1-A8A1-7C8BD2F070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D7C02AC-8648-420A-A4D2-E54E59F094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AF9E63E-605D-4E6E-86AF-4F47AE4020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63633-EAAC-4D73-8CD4-1F8AA98BFCAF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6F9F981-E6CF-4656-8D1D-172FB610C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53CA05D-B637-4309-8688-CD180FC67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E7812-F021-47EE-B160-0680F63B6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1044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FB6722-9DBD-4B1C-9CC0-1016AA261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84E232C-E50B-49A3-A8E7-66ADF92A1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63633-EAAC-4D73-8CD4-1F8AA98BFCAF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58E09E7-5B92-4C7B-8828-C391021D4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04B23F-E2FC-47E9-A178-0913BC14B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E7812-F021-47EE-B160-0680F63B6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0808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3871F9-9546-4951-97F4-0B5188BC7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63633-EAAC-4D73-8CD4-1F8AA98BFCAF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4B032A8-E978-402D-98C9-57007BEB0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00936E-8A19-41A8-9BEA-FDC7223A7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E7812-F021-47EE-B160-0680F63B6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7125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D2D512-FC06-458F-AE34-CEC9305BB4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769788-1D29-47D8-9EBB-B4B74B9B1C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043F0A-3154-4C9F-A28E-5964B75081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74C1EB-DAC9-4D57-BAB0-E81ABA1E39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63633-EAAC-4D73-8CD4-1F8AA98BFCAF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C3D7BE-4A53-4A44-9D0E-258EB5193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59C130-1D89-4194-B74E-88BE6A6B0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E7812-F021-47EE-B160-0680F63B6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3381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1195F0-99D0-4235-AB81-4AF78EC3D8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8A875A-B118-49F8-A67D-05E7F0CA4C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D40996-5D5D-439C-8CF9-E59BE47296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CBA69C-3803-44FC-B487-2253FB6C8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63633-EAAC-4D73-8CD4-1F8AA98BFCAF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5201-012B-4577-B7A5-940B52653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EDD9AD-FCAF-4400-83F7-79D418039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E7812-F021-47EE-B160-0680F63B6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6596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459C80-0A28-47C6-86C6-067D9FC86A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D5A0BA-7840-426E-808B-77217CE113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95B979-D14E-435D-9C5E-B795F0C5D0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463633-EAAC-4D73-8CD4-1F8AA98BFCAF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BCCB8D-087F-4BCD-BEF8-EBBF35A529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EB1EB5-B027-4528-A5CA-B48C91809E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7E7812-F021-47EE-B160-0680F63B6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2931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>
            <a:extLst>
              <a:ext uri="{FF2B5EF4-FFF2-40B4-BE49-F238E27FC236}">
                <a16:creationId xmlns:a16="http://schemas.microsoft.com/office/drawing/2014/main" id="{E5412232-ED05-4C68-82F0-B060F78D5675}"/>
              </a:ext>
            </a:extLst>
          </p:cNvPr>
          <p:cNvSpPr txBox="1"/>
          <p:nvPr/>
        </p:nvSpPr>
        <p:spPr>
          <a:xfrm>
            <a:off x="9363730" y="1210373"/>
            <a:ext cx="9598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Figure S2</a:t>
            </a:r>
          </a:p>
        </p:txBody>
      </p:sp>
      <p:grpSp>
        <p:nvGrpSpPr>
          <p:cNvPr id="49" name="Group 48">
            <a:extLst>
              <a:ext uri="{FF2B5EF4-FFF2-40B4-BE49-F238E27FC236}">
                <a16:creationId xmlns:a16="http://schemas.microsoft.com/office/drawing/2014/main" id="{23D693C8-BA71-48EC-B047-4A6C1BB39F20}"/>
              </a:ext>
            </a:extLst>
          </p:cNvPr>
          <p:cNvGrpSpPr/>
          <p:nvPr/>
        </p:nvGrpSpPr>
        <p:grpSpPr>
          <a:xfrm>
            <a:off x="1217449" y="1166684"/>
            <a:ext cx="8146281" cy="2238096"/>
            <a:chOff x="1293953" y="3698544"/>
            <a:chExt cx="8146281" cy="2238096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3657F9A-7437-454F-9476-12ACE60E78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454" t="19395" r="1540" b="29275"/>
            <a:stretch/>
          </p:blipFill>
          <p:spPr>
            <a:xfrm>
              <a:off x="2005764" y="3698544"/>
              <a:ext cx="7434470" cy="2238096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56165AE-3669-4358-BF90-EC1625B9851B}"/>
                </a:ext>
              </a:extLst>
            </p:cNvPr>
            <p:cNvSpPr txBox="1"/>
            <p:nvPr/>
          </p:nvSpPr>
          <p:spPr>
            <a:xfrm rot="16200000">
              <a:off x="8662068" y="4540086"/>
              <a:ext cx="3788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-ve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A20C827-5276-462C-B34F-B002370C0A1B}"/>
                </a:ext>
              </a:extLst>
            </p:cNvPr>
            <p:cNvSpPr txBox="1"/>
            <p:nvPr/>
          </p:nvSpPr>
          <p:spPr>
            <a:xfrm rot="16200000">
              <a:off x="8257026" y="4524858"/>
              <a:ext cx="4092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+ve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FFEAA50-EAD6-46DC-916D-7A133B4EB956}"/>
                </a:ext>
              </a:extLst>
            </p:cNvPr>
            <p:cNvSpPr txBox="1"/>
            <p:nvPr/>
          </p:nvSpPr>
          <p:spPr>
            <a:xfrm rot="16200000">
              <a:off x="2340129" y="4355036"/>
              <a:ext cx="7489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1473282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8B90D52-ADDA-4644-BE91-20D41C8A28E2}"/>
                </a:ext>
              </a:extLst>
            </p:cNvPr>
            <p:cNvSpPr txBox="1"/>
            <p:nvPr/>
          </p:nvSpPr>
          <p:spPr>
            <a:xfrm rot="16200000">
              <a:off x="2768031" y="4401523"/>
              <a:ext cx="6559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736641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E8AA6D7-7C3D-499A-97C1-E2CC556B0624}"/>
                </a:ext>
              </a:extLst>
            </p:cNvPr>
            <p:cNvSpPr txBox="1"/>
            <p:nvPr/>
          </p:nvSpPr>
          <p:spPr>
            <a:xfrm rot="16200000">
              <a:off x="3141100" y="4401523"/>
              <a:ext cx="6559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36832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0A64A5C-B6AE-49CA-B45B-46FB6A39FFBA}"/>
                </a:ext>
              </a:extLst>
            </p:cNvPr>
            <p:cNvSpPr txBox="1"/>
            <p:nvPr/>
          </p:nvSpPr>
          <p:spPr>
            <a:xfrm rot="16200000">
              <a:off x="3531801" y="4401523"/>
              <a:ext cx="6559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18416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E385D6E-0AD2-4D88-96EE-6A5EA055757F}"/>
                </a:ext>
              </a:extLst>
            </p:cNvPr>
            <p:cNvSpPr txBox="1"/>
            <p:nvPr/>
          </p:nvSpPr>
          <p:spPr>
            <a:xfrm rot="16200000">
              <a:off x="3951513" y="4440796"/>
              <a:ext cx="577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9208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6DD9917-6C50-4D15-9D10-111802EB4967}"/>
                </a:ext>
              </a:extLst>
            </p:cNvPr>
            <p:cNvSpPr txBox="1"/>
            <p:nvPr/>
          </p:nvSpPr>
          <p:spPr>
            <a:xfrm rot="16200000">
              <a:off x="4345682" y="4440796"/>
              <a:ext cx="577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4604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BB3744C-643D-482F-84CA-865013469640}"/>
                </a:ext>
              </a:extLst>
            </p:cNvPr>
            <p:cNvSpPr txBox="1"/>
            <p:nvPr/>
          </p:nvSpPr>
          <p:spPr>
            <a:xfrm rot="16200000">
              <a:off x="4724012" y="4440796"/>
              <a:ext cx="577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2302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BF946C7-9FB3-4472-A344-C25DCA607CF5}"/>
                </a:ext>
              </a:extLst>
            </p:cNvPr>
            <p:cNvSpPr txBox="1"/>
            <p:nvPr/>
          </p:nvSpPr>
          <p:spPr>
            <a:xfrm rot="16200000">
              <a:off x="5113979" y="4440796"/>
              <a:ext cx="577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1151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566E5C7-4C4D-45E3-AB6E-E01576BA3312}"/>
                </a:ext>
              </a:extLst>
            </p:cNvPr>
            <p:cNvSpPr txBox="1"/>
            <p:nvPr/>
          </p:nvSpPr>
          <p:spPr>
            <a:xfrm rot="16200000">
              <a:off x="5535784" y="4480070"/>
              <a:ext cx="4988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5755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F7F0BD1-0812-46B3-A0B5-8B5B4B3D3B90}"/>
                </a:ext>
              </a:extLst>
            </p:cNvPr>
            <p:cNvSpPr txBox="1"/>
            <p:nvPr/>
          </p:nvSpPr>
          <p:spPr>
            <a:xfrm rot="16200000">
              <a:off x="5900862" y="4480070"/>
              <a:ext cx="4988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2877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A900460-1DE8-4E93-AAF5-CAFE7D3AF3F1}"/>
                </a:ext>
              </a:extLst>
            </p:cNvPr>
            <p:cNvSpPr txBox="1"/>
            <p:nvPr/>
          </p:nvSpPr>
          <p:spPr>
            <a:xfrm rot="16200000">
              <a:off x="6282277" y="4480070"/>
              <a:ext cx="4988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1438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784E543-2D67-42B3-B9F5-B5ECA2051219}"/>
                </a:ext>
              </a:extLst>
            </p:cNvPr>
            <p:cNvSpPr txBox="1"/>
            <p:nvPr/>
          </p:nvSpPr>
          <p:spPr>
            <a:xfrm rot="16200000">
              <a:off x="6656081" y="4480070"/>
              <a:ext cx="4988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719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14B24EAD-9ED3-49DD-B0FC-1DBDAC58A115}"/>
                </a:ext>
              </a:extLst>
            </p:cNvPr>
            <p:cNvSpPr txBox="1"/>
            <p:nvPr/>
          </p:nvSpPr>
          <p:spPr>
            <a:xfrm rot="16200000">
              <a:off x="7073558" y="4480070"/>
              <a:ext cx="4988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359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9366CBE-3742-4F58-B2D6-4DBE46256BD7}"/>
                </a:ext>
              </a:extLst>
            </p:cNvPr>
            <p:cNvSpPr txBox="1"/>
            <p:nvPr/>
          </p:nvSpPr>
          <p:spPr>
            <a:xfrm rot="16200000">
              <a:off x="7438826" y="4480070"/>
              <a:ext cx="4988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179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7CE3EFBE-88BC-4A6B-B598-FDEB5F1563C7}"/>
                </a:ext>
              </a:extLst>
            </p:cNvPr>
            <p:cNvSpPr txBox="1"/>
            <p:nvPr/>
          </p:nvSpPr>
          <p:spPr>
            <a:xfrm rot="16200000">
              <a:off x="7842892" y="4480070"/>
              <a:ext cx="4988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90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83A57F3-D486-4119-93FE-B7D4534BB2B8}"/>
                </a:ext>
              </a:extLst>
            </p:cNvPr>
            <p:cNvSpPr txBox="1"/>
            <p:nvPr/>
          </p:nvSpPr>
          <p:spPr>
            <a:xfrm>
              <a:off x="2536677" y="3725841"/>
              <a:ext cx="5786490" cy="369332"/>
            </a:xfrm>
            <a:prstGeom prst="rect">
              <a:avLst/>
            </a:prstGeom>
            <a:noFill/>
            <a:ln w="28575"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solidFill>
                    <a:schemeClr val="bg1"/>
                  </a:solidFill>
                </a:rPr>
                <a:t>           Copies of repair template plasmid per target site</a:t>
              </a:r>
            </a:p>
          </p:txBody>
        </p:sp>
        <p:sp>
          <p:nvSpPr>
            <p:cNvPr id="46" name="Arrow: Right 45">
              <a:extLst>
                <a:ext uri="{FF2B5EF4-FFF2-40B4-BE49-F238E27FC236}">
                  <a16:creationId xmlns:a16="http://schemas.microsoft.com/office/drawing/2014/main" id="{0D649D1E-4C8E-4C06-A857-D8F6D90A8421}"/>
                </a:ext>
              </a:extLst>
            </p:cNvPr>
            <p:cNvSpPr/>
            <p:nvPr/>
          </p:nvSpPr>
          <p:spPr>
            <a:xfrm>
              <a:off x="1725481" y="5365181"/>
              <a:ext cx="186855" cy="45719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F8D1F96-FF08-4010-AE50-1CC04B82F4D7}"/>
                </a:ext>
              </a:extLst>
            </p:cNvPr>
            <p:cNvSpPr txBox="1"/>
            <p:nvPr/>
          </p:nvSpPr>
          <p:spPr>
            <a:xfrm>
              <a:off x="1293953" y="5266318"/>
              <a:ext cx="4315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1Kb</a:t>
              </a:r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B1F7632E-65C1-422C-932B-E56B48B81C60}"/>
              </a:ext>
            </a:extLst>
          </p:cNvPr>
          <p:cNvSpPr txBox="1"/>
          <p:nvPr/>
        </p:nvSpPr>
        <p:spPr>
          <a:xfrm>
            <a:off x="437219" y="5411495"/>
            <a:ext cx="1136609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200" dirty="0"/>
          </a:p>
          <a:p>
            <a:r>
              <a:rPr lang="en-GB" sz="1200" b="1" dirty="0"/>
              <a:t>Figure S2</a:t>
            </a:r>
          </a:p>
          <a:p>
            <a:r>
              <a:rPr lang="en-GB" sz="1200" dirty="0"/>
              <a:t>30ng of wild type barley DNA was mixed with serial dilutions of plasmid DNA containing the repair template. The lane numbers represent the copies of repair template: target site ratio. Positive control was a construct D line. The 1047bp band in lane 736641 was excised, purified and sequenced. </a:t>
            </a:r>
          </a:p>
        </p:txBody>
      </p:sp>
    </p:spTree>
    <p:extLst>
      <p:ext uri="{BB962C8B-B14F-4D97-AF65-F5344CB8AC3E}">
        <p14:creationId xmlns:p14="http://schemas.microsoft.com/office/powerpoint/2010/main" val="471938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87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 Lawrenson (JIC)</dc:creator>
  <cp:lastModifiedBy>Wendy Harwood (JIC)</cp:lastModifiedBy>
  <cp:revision>5</cp:revision>
  <dcterms:created xsi:type="dcterms:W3CDTF">2021-01-13T10:59:05Z</dcterms:created>
  <dcterms:modified xsi:type="dcterms:W3CDTF">2021-04-27T17:33:25Z</dcterms:modified>
</cp:coreProperties>
</file>